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482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8D60B-869E-4C3F-BE4F-E96C65BCE0BE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B4097-DC64-4067-A68C-B183F252F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72378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8D60B-869E-4C3F-BE4F-E96C65BCE0BE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B4097-DC64-4067-A68C-B183F252F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7394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8D60B-869E-4C3F-BE4F-E96C65BCE0BE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B4097-DC64-4067-A68C-B183F252F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7667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8D60B-869E-4C3F-BE4F-E96C65BCE0BE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B4097-DC64-4067-A68C-B183F252F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0059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8D60B-869E-4C3F-BE4F-E96C65BCE0BE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B4097-DC64-4067-A68C-B183F252F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61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8D60B-869E-4C3F-BE4F-E96C65BCE0BE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B4097-DC64-4067-A68C-B183F252F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7988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8D60B-869E-4C3F-BE4F-E96C65BCE0BE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B4097-DC64-4067-A68C-B183F252F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9278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8D60B-869E-4C3F-BE4F-E96C65BCE0BE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B4097-DC64-4067-A68C-B183F252F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0313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8D60B-869E-4C3F-BE4F-E96C65BCE0BE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B4097-DC64-4067-A68C-B183F252F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978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8D60B-869E-4C3F-BE4F-E96C65BCE0BE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B4097-DC64-4067-A68C-B183F252F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5167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8D60B-869E-4C3F-BE4F-E96C65BCE0BE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AB4097-DC64-4067-A68C-B183F252F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4791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48D60B-869E-4C3F-BE4F-E96C65BCE0BE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AB4097-DC64-4067-A68C-B183F252F0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203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="" xmlns:a16="http://schemas.microsoft.com/office/drawing/2014/main" id="{D634AA5D-9983-43DD-ADFA-6601B13D606E}"/>
              </a:ext>
            </a:extLst>
          </p:cNvPr>
          <p:cNvGrpSpPr/>
          <p:nvPr/>
        </p:nvGrpSpPr>
        <p:grpSpPr>
          <a:xfrm>
            <a:off x="541002" y="368480"/>
            <a:ext cx="5465528" cy="7443868"/>
            <a:chOff x="399516" y="368369"/>
            <a:chExt cx="6698617" cy="7418416"/>
          </a:xfrm>
        </p:grpSpPr>
        <p:sp>
          <p:nvSpPr>
            <p:cNvPr id="5" name="文本框 4">
              <a:extLst>
                <a:ext uri="{FF2B5EF4-FFF2-40B4-BE49-F238E27FC236}">
                  <a16:creationId xmlns="" xmlns:a16="http://schemas.microsoft.com/office/drawing/2014/main" id="{D627B0F6-0F98-4EB6-AB71-69954143348D}"/>
                </a:ext>
              </a:extLst>
            </p:cNvPr>
            <p:cNvSpPr txBox="1"/>
            <p:nvPr/>
          </p:nvSpPr>
          <p:spPr>
            <a:xfrm>
              <a:off x="5546217" y="368369"/>
              <a:ext cx="1551916" cy="67566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15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Glyma.16G208400 Glyma.15G142400 Glyma.12G101200 Glyma.07G065600 Glyma.07G063600  Glyma.08G352200 Glma.16G136600 Glyma.15G026900 Glyma.18G103700 Glyma.14G195000 Glyma.13G196500 Glyma.09G281800 Glyma.04G168400 Glyma.02G156800 Glyma.06G275700 Glyma.06G204200 Glyma.04G015900 Glyma.20G191600 Glyma.09G087700 Glyma.18G186400 Glyma.11G060900 Glyma.09G285700 Glyma.16G017600 Glyma.18G030400 Glyma.02G24960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" name="Picture 6">
              <a:extLst>
                <a:ext uri="{FF2B5EF4-FFF2-40B4-BE49-F238E27FC236}">
                  <a16:creationId xmlns="" xmlns:a16="http://schemas.microsoft.com/office/drawing/2014/main" id="{5A02C414-2279-42E3-B11F-3530E025A6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" t="2546" r="17004" b="8415"/>
            <a:stretch/>
          </p:blipFill>
          <p:spPr>
            <a:xfrm>
              <a:off x="399516" y="428753"/>
              <a:ext cx="5215224" cy="6551448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="" xmlns:a16="http://schemas.microsoft.com/office/drawing/2014/main" id="{3EA29F6E-F3E8-44A5-9B92-B6BF2D839A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5132" t="2546"/>
            <a:stretch/>
          </p:blipFill>
          <p:spPr>
            <a:xfrm>
              <a:off x="6808487" y="493188"/>
              <a:ext cx="287258" cy="7293597"/>
            </a:xfrm>
            <a:prstGeom prst="rect">
              <a:avLst/>
            </a:prstGeom>
          </p:spPr>
        </p:pic>
        <p:sp>
          <p:nvSpPr>
            <p:cNvPr id="8" name="文本框 7">
              <a:extLst>
                <a:ext uri="{FF2B5EF4-FFF2-40B4-BE49-F238E27FC236}">
                  <a16:creationId xmlns="" xmlns:a16="http://schemas.microsoft.com/office/drawing/2014/main" id="{8EBD0590-A67B-4A90-9281-FE498581427B}"/>
                </a:ext>
              </a:extLst>
            </p:cNvPr>
            <p:cNvSpPr txBox="1"/>
            <p:nvPr/>
          </p:nvSpPr>
          <p:spPr>
            <a:xfrm rot="16200000">
              <a:off x="2627276" y="4555360"/>
              <a:ext cx="1260578" cy="48713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CK1A</a:t>
              </a: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CK2A</a:t>
              </a: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CK3A</a:t>
              </a: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CK1A</a:t>
              </a: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CK2A</a:t>
              </a: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CK3A</a:t>
              </a: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021A</a:t>
              </a: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022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023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041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042A</a:t>
              </a: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043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081A</a:t>
              </a: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082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QH34083A</a:t>
              </a: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021A</a:t>
              </a: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022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023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041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042A</a:t>
              </a: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043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081A</a:t>
              </a: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082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32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N50083A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" name="TextBox 96">
            <a:extLst>
              <a:ext uri="{FF2B5EF4-FFF2-40B4-BE49-F238E27FC236}">
                <a16:creationId xmlns="" xmlns:a16="http://schemas.microsoft.com/office/drawing/2014/main" id="{2CB572A8-21B8-4BCE-8107-F7416C45F828}"/>
              </a:ext>
            </a:extLst>
          </p:cNvPr>
          <p:cNvSpPr txBox="1"/>
          <p:nvPr/>
        </p:nvSpPr>
        <p:spPr>
          <a:xfrm>
            <a:off x="404664" y="7646312"/>
            <a:ext cx="57606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.</a:t>
            </a:r>
            <a:r>
              <a:rPr lang="zh-CN" altLang="en-US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altLang="zh-CN" sz="900" b="1" dirty="0" smtClean="0">
                <a:latin typeface="Arial" charset="0"/>
                <a:ea typeface="Arial" charset="0"/>
                <a:cs typeface="Arial" charset="0"/>
              </a:rPr>
              <a:t>S5</a:t>
            </a:r>
            <a:r>
              <a:rPr lang="en-US" altLang="zh-CN" sz="900" b="1" dirty="0" smtClean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altLang="zh-CN" sz="900" b="1" dirty="0" err="1" smtClean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Heatmap</a:t>
            </a:r>
            <a:r>
              <a:rPr lang="en-US" altLang="zh-CN" sz="900" b="1" dirty="0" smtClean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altLang="zh-CN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of </a:t>
            </a:r>
            <a:r>
              <a:rPr lang="en-US" altLang="zh-CN" sz="900" b="1" dirty="0" smtClean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negative </a:t>
            </a:r>
            <a:r>
              <a:rPr lang="en-US" altLang="zh-CN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regulation of </a:t>
            </a:r>
            <a:r>
              <a:rPr lang="en-US" altLang="zh-CN" sz="900" b="1" dirty="0" smtClean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roteolysis signaling pathway</a:t>
            </a:r>
            <a:r>
              <a:rPr lang="en-US" altLang="zh-CN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 </a:t>
            </a:r>
            <a:r>
              <a:rPr lang="en-US" altLang="zh-CN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K, 02, 04 and 08 represent 0, 2, 4 and 8 hours of salt treatment, respectively. 1A, 2A and 3A represent three biological replicates</a:t>
            </a:r>
            <a:r>
              <a:rPr lang="en-US" altLang="zh-CN" sz="900" dirty="0" smtClean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</a:t>
            </a:r>
            <a:endParaRPr lang="en-US" altLang="zh-CN" sz="9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06248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3</Words>
  <Application>Microsoft Office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F45</dc:creator>
  <cp:lastModifiedBy>OF45</cp:lastModifiedBy>
  <cp:revision>1</cp:revision>
  <dcterms:created xsi:type="dcterms:W3CDTF">2022-03-27T00:05:01Z</dcterms:created>
  <dcterms:modified xsi:type="dcterms:W3CDTF">2022-03-27T00:05:21Z</dcterms:modified>
</cp:coreProperties>
</file>